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5DAC"/>
    <a:srgbClr val="BEBEBE"/>
    <a:srgbClr val="9EB7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597"/>
    <p:restoredTop sz="95033" autoAdjust="0"/>
  </p:normalViewPr>
  <p:slideViewPr>
    <p:cSldViewPr snapToGrid="0">
      <p:cViewPr varScale="1">
        <p:scale>
          <a:sx n="54" d="100"/>
          <a:sy n="54" d="100"/>
        </p:scale>
        <p:origin x="286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51BF788-A5AC-4563-836F-A6517E13EDF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83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AFD37610-53A2-45F4-BA32-511312CCA45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5114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610-53A2-45F4-BA32-511312CCA45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7715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7159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5457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814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5655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6060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833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7395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996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025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019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559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022E4-0969-459A-874F-1BDC4BF56F89}" type="datetimeFigureOut">
              <a:rPr lang="es-ES" smtClean="0"/>
              <a:t>27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B4758B-12D1-4B63-BA8D-C4AB3F71AE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7466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oleObject" Target="../embeddings/oleObject8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6" Type="http://schemas.openxmlformats.org/officeDocument/2006/relationships/oleObject" Target="../embeddings/oleObject7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png"/><Relationship Id="rId10" Type="http://schemas.openxmlformats.org/officeDocument/2006/relationships/image" Target="../media/image4.emf"/><Relationship Id="rId19" Type="http://schemas.openxmlformats.org/officeDocument/2006/relationships/image" Target="../media/image9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7C7E90-3CC9-0B37-677D-581B02218E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EA1F145D-5011-8091-050E-061C80F3EE20}"/>
              </a:ext>
            </a:extLst>
          </p:cNvPr>
          <p:cNvSpPr txBox="1"/>
          <p:nvPr/>
        </p:nvSpPr>
        <p:spPr>
          <a:xfrm>
            <a:off x="410019" y="5424325"/>
            <a:ext cx="6037962" cy="1852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Mice weight and muscle weight of control, vehicle and </a:t>
            </a:r>
            <a:r>
              <a:rPr lang="en-GB" sz="1000" b="1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ed </a:t>
            </a:r>
            <a:r>
              <a:rPr lang="en-GB" sz="1000" b="1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SOD1</a:t>
            </a:r>
            <a:r>
              <a:rPr lang="en-GB" sz="1000" b="1" i="1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93A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at end-stage. a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weight at end-stage,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ariation in body mass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ibialis anterior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A), quadriceps, 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tensor digitorum longus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EDL), biceps, 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astrocnemius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Gastro), 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triceps weight starting the treatment with </a:t>
            </a:r>
            <a:r>
              <a:rPr lang="en-GB" sz="10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FOXO inhibitor) at </a:t>
            </a:r>
            <a:r>
              <a:rPr lang="en-US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t symptomatic postnatal day 90 (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90).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weight at end-stage,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ariation in body mass and </a:t>
            </a:r>
            <a:r>
              <a:rPr lang="en-GB" sz="10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A, quadriceps, EDL, biceps, </a:t>
            </a:r>
            <a:r>
              <a:rPr lang="en-GB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astro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triceps weight starting the treatment with </a:t>
            </a:r>
            <a:r>
              <a:rPr lang="en-GB" sz="10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OXO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t presymptomatic P50. WT, control mice. Data are expressed as mean ± SD. n=5-9/group.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or normally distributed data with equal variances, one-way ANOVA followed by Tukey’s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 hoc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est was applied. When variances were unequal, Welch ANOVA followed by Games–Howell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 hoc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est was used. For non-normally distributed data, the Kruskal-Wallis test followed by Dunn’s </a:t>
            </a:r>
            <a:r>
              <a:rPr lang="en-US" sz="1000" i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ost hoc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est was applied.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ignificant differences are indicated as *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0.05,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*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0.01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**</a:t>
            </a:r>
            <a:r>
              <a:rPr lang="en-GB" sz="1000" i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0.001.</a:t>
            </a:r>
            <a:endParaRPr lang="es-ES" sz="10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14B15743-DA55-859D-5029-F0BC5126BF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1910784"/>
              </p:ext>
            </p:extLst>
          </p:nvPr>
        </p:nvGraphicFramePr>
        <p:xfrm>
          <a:off x="392113" y="3559179"/>
          <a:ext cx="1139825" cy="1839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1988747" imgH="3215177" progId="Prism8.Document">
                  <p:embed/>
                </p:oleObj>
              </mc:Choice>
              <mc:Fallback>
                <p:oleObj name="Prism 8" r:id="rId3" imgW="1988747" imgH="321517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2113" y="3559179"/>
                        <a:ext cx="1139825" cy="1839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E398F409-FE6C-1788-888A-DB45284ED1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2007078"/>
              </p:ext>
            </p:extLst>
          </p:nvPr>
        </p:nvGraphicFramePr>
        <p:xfrm>
          <a:off x="395288" y="1589088"/>
          <a:ext cx="1125537" cy="1720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1988747" imgH="3045995" progId="Prism8.Document">
                  <p:embed/>
                </p:oleObj>
              </mc:Choice>
              <mc:Fallback>
                <p:oleObj name="Prism 8" r:id="rId5" imgW="1988747" imgH="304599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288" y="1589088"/>
                        <a:ext cx="1125537" cy="1720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7C4EF1EC-057E-BC6E-80B6-B42F6030A1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6587807"/>
              </p:ext>
            </p:extLst>
          </p:nvPr>
        </p:nvGraphicFramePr>
        <p:xfrm>
          <a:off x="1465263" y="1691323"/>
          <a:ext cx="1947862" cy="1414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779160" imgH="2742908" progId="Prism8.Document">
                  <p:embed/>
                </p:oleObj>
              </mc:Choice>
              <mc:Fallback>
                <p:oleObj name="Prism 8" r:id="rId7" imgW="3779160" imgH="27429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65263" y="1691323"/>
                        <a:ext cx="1947862" cy="1414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o 20">
            <a:extLst>
              <a:ext uri="{FF2B5EF4-FFF2-40B4-BE49-F238E27FC236}">
                <a16:creationId xmlns:a16="http://schemas.microsoft.com/office/drawing/2014/main" id="{4C2AC56B-3F97-11F7-0EA9-2C5DBFBCD9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5389279"/>
              </p:ext>
            </p:extLst>
          </p:nvPr>
        </p:nvGraphicFramePr>
        <p:xfrm>
          <a:off x="1463675" y="3628077"/>
          <a:ext cx="1949450" cy="1416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3779160" imgH="2742908" progId="Prism8.Document">
                  <p:embed/>
                </p:oleObj>
              </mc:Choice>
              <mc:Fallback>
                <p:oleObj name="Prism 8" r:id="rId9" imgW="3779160" imgH="27429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63675" y="3628077"/>
                        <a:ext cx="1949450" cy="1416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CuadroTexto 40">
            <a:extLst>
              <a:ext uri="{FF2B5EF4-FFF2-40B4-BE49-F238E27FC236}">
                <a16:creationId xmlns:a16="http://schemas.microsoft.com/office/drawing/2014/main" id="{C236D4E0-D134-F490-8A6E-40E18EFAE4E5}"/>
              </a:ext>
            </a:extLst>
          </p:cNvPr>
          <p:cNvSpPr txBox="1"/>
          <p:nvPr/>
        </p:nvSpPr>
        <p:spPr>
          <a:xfrm>
            <a:off x="309492" y="1310640"/>
            <a:ext cx="392212" cy="3516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CuadroTexto 41">
            <a:extLst>
              <a:ext uri="{FF2B5EF4-FFF2-40B4-BE49-F238E27FC236}">
                <a16:creationId xmlns:a16="http://schemas.microsoft.com/office/drawing/2014/main" id="{1A915A97-BFC3-86D7-1292-76A38DA2335F}"/>
              </a:ext>
            </a:extLst>
          </p:cNvPr>
          <p:cNvSpPr txBox="1"/>
          <p:nvPr/>
        </p:nvSpPr>
        <p:spPr>
          <a:xfrm>
            <a:off x="1413122" y="1325880"/>
            <a:ext cx="244424" cy="3874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b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CuadroTexto 42">
            <a:extLst>
              <a:ext uri="{FF2B5EF4-FFF2-40B4-BE49-F238E27FC236}">
                <a16:creationId xmlns:a16="http://schemas.microsoft.com/office/drawing/2014/main" id="{4D53A5A5-40F1-67DA-D53F-89E705F061DA}"/>
              </a:ext>
            </a:extLst>
          </p:cNvPr>
          <p:cNvSpPr txBox="1"/>
          <p:nvPr/>
        </p:nvSpPr>
        <p:spPr>
          <a:xfrm>
            <a:off x="3179496" y="1325880"/>
            <a:ext cx="259498" cy="38745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c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CuadroTexto 40">
            <a:extLst>
              <a:ext uri="{FF2B5EF4-FFF2-40B4-BE49-F238E27FC236}">
                <a16:creationId xmlns:a16="http://schemas.microsoft.com/office/drawing/2014/main" id="{3BB970CF-A328-8C3F-BB5D-0A144DA4B79D}"/>
              </a:ext>
            </a:extLst>
          </p:cNvPr>
          <p:cNvSpPr txBox="1"/>
          <p:nvPr/>
        </p:nvSpPr>
        <p:spPr>
          <a:xfrm>
            <a:off x="309492" y="3266440"/>
            <a:ext cx="391795" cy="3632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d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CuadroTexto 40">
            <a:extLst>
              <a:ext uri="{FF2B5EF4-FFF2-40B4-BE49-F238E27FC236}">
                <a16:creationId xmlns:a16="http://schemas.microsoft.com/office/drawing/2014/main" id="{4D49F324-163F-E6E9-1A60-9651D472D8B3}"/>
              </a:ext>
            </a:extLst>
          </p:cNvPr>
          <p:cNvSpPr txBox="1"/>
          <p:nvPr/>
        </p:nvSpPr>
        <p:spPr>
          <a:xfrm>
            <a:off x="1413122" y="3266440"/>
            <a:ext cx="391795" cy="3632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CuadroTexto 40">
            <a:extLst>
              <a:ext uri="{FF2B5EF4-FFF2-40B4-BE49-F238E27FC236}">
                <a16:creationId xmlns:a16="http://schemas.microsoft.com/office/drawing/2014/main" id="{8537AB87-24D1-8E10-AA7A-7DCC1A022471}"/>
              </a:ext>
            </a:extLst>
          </p:cNvPr>
          <p:cNvSpPr txBox="1"/>
          <p:nvPr/>
        </p:nvSpPr>
        <p:spPr>
          <a:xfrm>
            <a:off x="3179496" y="3266440"/>
            <a:ext cx="391795" cy="3632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s-ES" sz="1500" b="1" dirty="0">
                <a:solidFill>
                  <a:srgbClr val="000000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f</a:t>
            </a:r>
            <a:endParaRPr lang="es-ES" sz="1200" kern="100" dirty="0"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58542B87-3C2C-90D1-FF8F-F776EA93B161}"/>
              </a:ext>
            </a:extLst>
          </p:cNvPr>
          <p:cNvSpPr/>
          <p:nvPr/>
        </p:nvSpPr>
        <p:spPr>
          <a:xfrm>
            <a:off x="3347067" y="1673578"/>
            <a:ext cx="697813" cy="5881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70B4DAA4-1B99-6B55-B0C0-6C2EE9FF58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0694030"/>
              </p:ext>
            </p:extLst>
          </p:nvPr>
        </p:nvGraphicFramePr>
        <p:xfrm>
          <a:off x="3206117" y="1588135"/>
          <a:ext cx="1812925" cy="145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686339" imgH="2148611" progId="Prism8.Document">
                  <p:embed/>
                </p:oleObj>
              </mc:Choice>
              <mc:Fallback>
                <p:oleObj name="Prism 8" r:id="rId11" imgW="2686339" imgH="214861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206117" y="1588135"/>
                        <a:ext cx="1812925" cy="145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CuadroTexto 27">
            <a:extLst>
              <a:ext uri="{FF2B5EF4-FFF2-40B4-BE49-F238E27FC236}">
                <a16:creationId xmlns:a16="http://schemas.microsoft.com/office/drawing/2014/main" id="{14169AAF-938E-6343-39B7-2359D1C1433C}"/>
              </a:ext>
            </a:extLst>
          </p:cNvPr>
          <p:cNvSpPr txBox="1"/>
          <p:nvPr/>
        </p:nvSpPr>
        <p:spPr>
          <a:xfrm>
            <a:off x="3020074" y="1161941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90-treated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72953F64-8EEC-DFC5-8092-FF9C2FCBF237}"/>
              </a:ext>
            </a:extLst>
          </p:cNvPr>
          <p:cNvSpPr txBox="1"/>
          <p:nvPr/>
        </p:nvSpPr>
        <p:spPr>
          <a:xfrm>
            <a:off x="3020074" y="3110572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0-treated</a:t>
            </a:r>
          </a:p>
        </p:txBody>
      </p:sp>
      <p:graphicFrame>
        <p:nvGraphicFramePr>
          <p:cNvPr id="30" name="Objeto 29">
            <a:extLst>
              <a:ext uri="{FF2B5EF4-FFF2-40B4-BE49-F238E27FC236}">
                <a16:creationId xmlns:a16="http://schemas.microsoft.com/office/drawing/2014/main" id="{70B4DAA4-1B99-6B55-B0C0-6C2EE9FF58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471753"/>
              </p:ext>
            </p:extLst>
          </p:nvPr>
        </p:nvGraphicFramePr>
        <p:xfrm>
          <a:off x="4906963" y="1614170"/>
          <a:ext cx="1876425" cy="1439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640625" imgH="2031263" progId="Prism8.Document">
                  <p:embed/>
                </p:oleObj>
              </mc:Choice>
              <mc:Fallback>
                <p:oleObj name="Prism 8" r:id="rId13" imgW="2640625" imgH="2031263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70B4DAA4-1B99-6B55-B0C0-6C2EE9FF58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906963" y="1614170"/>
                        <a:ext cx="1876425" cy="1439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Imagen 3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340414" y="5152951"/>
            <a:ext cx="1936994" cy="142123"/>
          </a:xfrm>
          <a:prstGeom prst="rect">
            <a:avLst/>
          </a:prstGeom>
        </p:spPr>
      </p:pic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8291A7FB-02F1-5D40-C216-DB4945F304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1747533"/>
              </p:ext>
            </p:extLst>
          </p:nvPr>
        </p:nvGraphicFramePr>
        <p:xfrm>
          <a:off x="3209292" y="3527112"/>
          <a:ext cx="1812925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686339" imgH="2148611" progId="Prism8.Document">
                  <p:embed/>
                </p:oleObj>
              </mc:Choice>
              <mc:Fallback>
                <p:oleObj name="Prism 8" r:id="rId16" imgW="2686339" imgH="2148611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70B4DAA4-1B99-6B55-B0C0-6C2EE9FF58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209292" y="3527112"/>
                        <a:ext cx="1812925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7A3632FB-AD37-1A95-A6ED-717D319FEB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9800729"/>
              </p:ext>
            </p:extLst>
          </p:nvPr>
        </p:nvGraphicFramePr>
        <p:xfrm>
          <a:off x="4906963" y="3436942"/>
          <a:ext cx="1876425" cy="155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2640625" imgH="2195766" progId="Prism8.Document">
                  <p:embed/>
                </p:oleObj>
              </mc:Choice>
              <mc:Fallback>
                <p:oleObj name="Prism 8" r:id="rId18" imgW="2640625" imgH="2195766" progId="Prism8.Document">
                  <p:embed/>
                  <p:pic>
                    <p:nvPicPr>
                      <p:cNvPr id="30" name="Objeto 29">
                        <a:extLst>
                          <a:ext uri="{FF2B5EF4-FFF2-40B4-BE49-F238E27FC236}">
                            <a16:creationId xmlns:a16="http://schemas.microsoft.com/office/drawing/2014/main" id="{70B4DAA4-1B99-6B55-B0C0-6C2EE9FF58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906963" y="3436942"/>
                        <a:ext cx="1876425" cy="155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66642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10</TotalTime>
  <Words>219</Words>
  <Application>Microsoft Office PowerPoint</Application>
  <PresentationFormat>A4 (210 x 297 mm)</PresentationFormat>
  <Paragraphs>10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ema de Office</vt:lpstr>
      <vt:lpstr>Prism 8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NHOA VIDAL GIL</dc:creator>
  <cp:lastModifiedBy>AINHOA VIDAL GIL</cp:lastModifiedBy>
  <cp:revision>387</cp:revision>
  <cp:lastPrinted>2026-03-24T15:11:51Z</cp:lastPrinted>
  <dcterms:created xsi:type="dcterms:W3CDTF">2025-08-03T15:24:02Z</dcterms:created>
  <dcterms:modified xsi:type="dcterms:W3CDTF">2026-05-27T13:32:19Z</dcterms:modified>
</cp:coreProperties>
</file>